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>
      <p:cViewPr varScale="1">
        <p:scale>
          <a:sx n="62" d="100"/>
          <a:sy n="62" d="100"/>
        </p:scale>
        <p:origin x="776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761D0D-8C24-709C-83B4-EA819CCCFD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515DC82-265A-ABB4-27C4-F1C35E3A2AB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EA53CB-7DEF-6933-0D7A-96236407D7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D1EE1-0C37-4D54-9477-FF451ABA9AFC}" type="datetimeFigureOut">
              <a:rPr lang="en-ZA" smtClean="0"/>
              <a:t>2022/06/22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C8A065-EA1A-2DFD-0447-A3FC4288BF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D639E2-2582-3F93-8FC1-7B01334E13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63D93C-FAF2-4B1D-A7F0-2ADD0CFAB2C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837693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36F543-EDD3-44FB-7CA9-9C10F31670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5E11C7-909A-FC33-439D-96D2F5A661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17940E-DF66-39BE-A00D-AD8DC8EFB4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D1EE1-0C37-4D54-9477-FF451ABA9AFC}" type="datetimeFigureOut">
              <a:rPr lang="en-ZA" smtClean="0"/>
              <a:t>2022/06/22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70EE06-BEF9-F470-CEEA-C8B83B8DDA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B552D5-489F-CDDC-94CA-56CD7B201A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63D93C-FAF2-4B1D-A7F0-2ADD0CFAB2C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666353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45F7638-60A8-70FB-6E04-1746594BE4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6424FFA-4FD1-B768-52D2-CB87090CAB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0059EA-0443-89FC-CD88-FE5DDFECA1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D1EE1-0C37-4D54-9477-FF451ABA9AFC}" type="datetimeFigureOut">
              <a:rPr lang="en-ZA" smtClean="0"/>
              <a:t>2022/06/22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83BE84-85B2-3855-D1E9-463834A734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12CEFB-FA96-B42C-BBBB-1C35FF9795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63D93C-FAF2-4B1D-A7F0-2ADD0CFAB2C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201605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E71993-4368-FBFD-47F4-8C5104BEED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EC1279-1E79-3FAF-D2A1-CF6B8D8BD3C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33CE05-DA9B-9C12-0AE0-C43602B3BF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D1EE1-0C37-4D54-9477-FF451ABA9AFC}" type="datetimeFigureOut">
              <a:rPr lang="en-ZA" smtClean="0"/>
              <a:t>2022/06/22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03E749-6326-ABCE-191C-994DF9A4B4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6DCED8-8578-8525-E690-4E296DC966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63D93C-FAF2-4B1D-A7F0-2ADD0CFAB2C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98284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2E4EF5-2FB9-EF49-050E-5897169532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9CB7F5-7899-82A8-F5C4-3817A32440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57B210-2287-E114-ACAD-B85936273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D1EE1-0C37-4D54-9477-FF451ABA9AFC}" type="datetimeFigureOut">
              <a:rPr lang="en-ZA" smtClean="0"/>
              <a:t>2022/06/22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311D76-8277-B2CC-32C2-C1102E86BD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22234E-FFDE-5E93-AD0C-6DB6A6FD1A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63D93C-FAF2-4B1D-A7F0-2ADD0CFAB2C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04657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69377C-A8E5-03C7-0BDC-59A7B70BB0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D72568-D708-4ADA-7C6B-F55E2DFCAB0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C618DBF-E648-486F-C697-9A8000C0FE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B45215-1B9C-FF34-F7A5-41BDCC2DC7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D1EE1-0C37-4D54-9477-FF451ABA9AFC}" type="datetimeFigureOut">
              <a:rPr lang="en-ZA" smtClean="0"/>
              <a:t>2022/06/22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A12D41-39D7-7B53-7143-B508059E85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180738-5ABE-E8E3-8BC3-0840A46767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63D93C-FAF2-4B1D-A7F0-2ADD0CFAB2C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267842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2D92CF-D677-A235-812C-99E418BF15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FB2516-5277-0E4A-1A81-E9284A78D5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0CC3FF7-231F-A715-1A0C-F789CA68DC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C72070C-3839-039F-DA05-E9F09B86FFE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199E390-A091-415F-0458-C6F2E7C8CA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314F5F3-D702-5EB6-1FCD-510A2070FB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D1EE1-0C37-4D54-9477-FF451ABA9AFC}" type="datetimeFigureOut">
              <a:rPr lang="en-ZA" smtClean="0"/>
              <a:t>2022/06/22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806C48A-F458-0644-686E-1D0BE584D9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C9D9A8C-BDEA-DF19-D827-E53D6E0278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63D93C-FAF2-4B1D-A7F0-2ADD0CFAB2C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806694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2BD02F-D3A4-7B16-26A1-69221B1BF4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7B521B1-08FA-E8E4-5486-6AE888D520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D1EE1-0C37-4D54-9477-FF451ABA9AFC}" type="datetimeFigureOut">
              <a:rPr lang="en-ZA" smtClean="0"/>
              <a:t>2022/06/22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6EDCDA3-372E-A7A9-36B6-9505A554F3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209024A-8049-7B52-95A0-4475FBDA4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63D93C-FAF2-4B1D-A7F0-2ADD0CFAB2C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42589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4BDF23A-23A0-3604-72BE-240553B147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D1EE1-0C37-4D54-9477-FF451ABA9AFC}" type="datetimeFigureOut">
              <a:rPr lang="en-ZA" smtClean="0"/>
              <a:t>2022/06/22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523FBF1-2AC2-9B1B-FEEB-BE677A4B5A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16089EA-28DC-467B-E986-83C72B8069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63D93C-FAF2-4B1D-A7F0-2ADD0CFAB2C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503093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B1338B-2E33-95DF-8B4A-336322DEB6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8EB391-C8A7-E7C6-0E03-EC05B8BBF26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C9904C-0233-73EA-8F99-8CD65DF89C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65551F-3FAF-EBD3-75E1-5FC67036F8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D1EE1-0C37-4D54-9477-FF451ABA9AFC}" type="datetimeFigureOut">
              <a:rPr lang="en-ZA" smtClean="0"/>
              <a:t>2022/06/22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CD64260-4DA4-3BD3-376D-E82A7F755E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7AF03C-B51D-AD55-AEAF-BCC1093BF4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63D93C-FAF2-4B1D-A7F0-2ADD0CFAB2C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47134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467340-E183-2440-C01B-71E5230F40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051EDCA-1733-0F13-DA54-ED58A48DA2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E0F2C9B-3D9F-3DB8-A94F-1312CC9239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A999AC-3596-A077-1EA8-2EA2D4B591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D1EE1-0C37-4D54-9477-FF451ABA9AFC}" type="datetimeFigureOut">
              <a:rPr lang="en-ZA" smtClean="0"/>
              <a:t>2022/06/22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83C59A-A810-B212-1CEA-1FAC058964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F6A229-77B5-B92F-192A-3FF9BAE46A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63D93C-FAF2-4B1D-A7F0-2ADD0CFAB2C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05333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6632DD3-B0EB-EBA9-5C57-1C5F62A548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B4FF06-174B-77B4-881F-79A43EF686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4544E2-0A88-8376-6C67-D5992389F5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2D1EE1-0C37-4D54-9477-FF451ABA9AFC}" type="datetimeFigureOut">
              <a:rPr lang="en-ZA" smtClean="0"/>
              <a:t>2022/06/22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43B063-6E76-2644-9EE8-C4DAC30D994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235C8B-B09A-B979-6EDF-9504F9DB23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63D93C-FAF2-4B1D-A7F0-2ADD0CFAB2C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647466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ontent Placeholder 4">
            <a:extLst>
              <a:ext uri="{FF2B5EF4-FFF2-40B4-BE49-F238E27FC236}">
                <a16:creationId xmlns:a16="http://schemas.microsoft.com/office/drawing/2014/main" id="{9A30E35F-BEE2-147D-D2B6-B89E37D72B4D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189357853"/>
              </p:ext>
            </p:extLst>
          </p:nvPr>
        </p:nvGraphicFramePr>
        <p:xfrm>
          <a:off x="888714" y="1844211"/>
          <a:ext cx="10921431" cy="3913477"/>
        </p:xfrm>
        <a:graphic>
          <a:graphicData uri="http://schemas.openxmlformats.org/drawingml/2006/table">
            <a:tbl>
              <a:tblPr firstRow="1" firstCol="1" bandRow="1"/>
              <a:tblGrid>
                <a:gridCol w="1811394">
                  <a:extLst>
                    <a:ext uri="{9D8B030D-6E8A-4147-A177-3AD203B41FA5}">
                      <a16:colId xmlns:a16="http://schemas.microsoft.com/office/drawing/2014/main" val="2870723179"/>
                    </a:ext>
                  </a:extLst>
                </a:gridCol>
                <a:gridCol w="1828279">
                  <a:extLst>
                    <a:ext uri="{9D8B030D-6E8A-4147-A177-3AD203B41FA5}">
                      <a16:colId xmlns:a16="http://schemas.microsoft.com/office/drawing/2014/main" val="1730535480"/>
                    </a:ext>
                  </a:extLst>
                </a:gridCol>
                <a:gridCol w="1812600">
                  <a:extLst>
                    <a:ext uri="{9D8B030D-6E8A-4147-A177-3AD203B41FA5}">
                      <a16:colId xmlns:a16="http://schemas.microsoft.com/office/drawing/2014/main" val="2899060122"/>
                    </a:ext>
                  </a:extLst>
                </a:gridCol>
                <a:gridCol w="1828279">
                  <a:extLst>
                    <a:ext uri="{9D8B030D-6E8A-4147-A177-3AD203B41FA5}">
                      <a16:colId xmlns:a16="http://schemas.microsoft.com/office/drawing/2014/main" val="2159656478"/>
                    </a:ext>
                  </a:extLst>
                </a:gridCol>
                <a:gridCol w="1828279">
                  <a:extLst>
                    <a:ext uri="{9D8B030D-6E8A-4147-A177-3AD203B41FA5}">
                      <a16:colId xmlns:a16="http://schemas.microsoft.com/office/drawing/2014/main" val="4206638779"/>
                    </a:ext>
                  </a:extLst>
                </a:gridCol>
                <a:gridCol w="1812600">
                  <a:extLst>
                    <a:ext uri="{9D8B030D-6E8A-4147-A177-3AD203B41FA5}">
                      <a16:colId xmlns:a16="http://schemas.microsoft.com/office/drawing/2014/main" val="324109240"/>
                    </a:ext>
                  </a:extLst>
                </a:gridCol>
              </a:tblGrid>
              <a:tr h="254285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50 reporting positive HIVSS result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ZAR150 Time compensation for competing confirmatory test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ZAR75 intervention only incentive for completing confirmatory test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ZAR25 intervention only reward for submitting photographic evidence of medication collection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ZAR150 Time compensation for completing follow-up appointment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ZAR300 intervention only incentive for achieving VS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1855689"/>
                  </a:ext>
                </a:extLst>
              </a:tr>
              <a:tr h="37500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AR Programm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AR Programme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AR Programme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AR Programme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AR Programme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AR Programme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1378526"/>
                  </a:ext>
                </a:extLst>
              </a:tr>
              <a:tr h="3318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CV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CV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CV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CV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5645831"/>
                  </a:ext>
                </a:extLst>
              </a:tr>
              <a:tr h="3318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dia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dia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dia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dia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6757218"/>
                  </a:ext>
                </a:extLst>
              </a:tr>
              <a:tr h="3318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OVA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OVA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OVA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OVA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9705386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AA57FB0A-B3EB-D2AE-613A-04A158487F30}"/>
              </a:ext>
            </a:extLst>
          </p:cNvPr>
          <p:cNvSpPr txBox="1"/>
          <p:nvPr/>
        </p:nvSpPr>
        <p:spPr>
          <a:xfrm>
            <a:off x="833491" y="1340505"/>
            <a:ext cx="6095144" cy="375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Z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S1:  Incentive summary</a:t>
            </a:r>
          </a:p>
        </p:txBody>
      </p:sp>
    </p:spTree>
    <p:extLst>
      <p:ext uri="{BB962C8B-B14F-4D97-AF65-F5344CB8AC3E}">
        <p14:creationId xmlns:p14="http://schemas.microsoft.com/office/powerpoint/2010/main" val="39103750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80</Words>
  <Application>Microsoft Office PowerPoint</Application>
  <PresentationFormat>Widescreen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anta Lalla-Edward</dc:creator>
  <cp:lastModifiedBy>Samanta Lalla-Edward</cp:lastModifiedBy>
  <cp:revision>3</cp:revision>
  <dcterms:created xsi:type="dcterms:W3CDTF">2022-06-21T21:45:59Z</dcterms:created>
  <dcterms:modified xsi:type="dcterms:W3CDTF">2022-06-21T22:53:03Z</dcterms:modified>
</cp:coreProperties>
</file>